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12192000" cy="6858000"/>
  <p:notesSz cx="6858000" cy="9144000"/>
  <p:defaultTextStyle>
    <a:defPPr>
      <a:defRPr lang="en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736"/>
    <p:restoredTop sz="86386"/>
  </p:normalViewPr>
  <p:slideViewPr>
    <p:cSldViewPr snapToGrid="0">
      <p:cViewPr varScale="1">
        <p:scale>
          <a:sx n="75" d="100"/>
          <a:sy n="75" d="100"/>
        </p:scale>
        <p:origin x="1440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2F05CE1-4288-8042-A4DE-9BCC0CF47560}" type="datetimeFigureOut">
              <a:rPr lang="en-ES" smtClean="0"/>
              <a:t>9/4/26</a:t>
            </a:fld>
            <a:endParaRPr lang="en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E8267F-6ACE-3241-B786-8F3C9F9FC30F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8116966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8E8267F-6ACE-3241-B786-8F3C9F9FC30F}" type="slidenum">
              <a:rPr lang="en-ES" smtClean="0"/>
              <a:t>1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13243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078BCE-BF24-A93A-E579-4AA6B062C3F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30AC4AA-5BAA-2E5F-FBDE-26E541C9145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9D25F4-F5BD-D813-B369-58B9F02CA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48D66C-34CA-D2DF-9621-76E7CA6AF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812A0E-4D4C-F988-BC71-F89846A795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580481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48398E-1640-8CE6-4508-51B8F6AC69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A003A49-4A68-50B3-9354-6E3FC5AB7C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56B7CA-AFCD-971B-DE93-433DCB35D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D206EF-FFBD-5FF2-12A5-2DB27CFFB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05D472-34F3-8709-F501-96F656AFD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78776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C40CFA1-60EC-A667-1D46-EE79B3A9919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341741-5C2E-9D43-0D4C-ED9F94D86D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F13FBB-0D71-4417-594F-1D2B687A15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BDC588-1C48-E808-5544-BD7A0954D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27800E-888F-2C0B-E45A-75B7C22A7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4343769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3E343E-166A-B537-8C0D-67A3EC073A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529277-5062-4420-777D-DBD56BAA76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FC5D11-6A43-3807-8EDC-4F1D3F847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602039-446E-E474-6233-5B23A5E8D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19B939-FF04-F97D-39BD-682A47902F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626747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69CA7C-A8B0-438C-694C-8AD326B3C5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C3E12E-DAAD-5A11-727B-EDB17D8F2C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060D7E-A7AE-AD32-E9BA-A65E08C9B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CF12CC-9AF2-F6C7-4D7C-804F63602E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A318FE-E151-6923-1248-7A529986CF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204645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6047AD-7601-5B8A-D137-9A38B4931D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AAFE0C-2FCE-D2DA-848C-4C2A91AC88F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B8457F-3EEC-AC16-3FCC-76729C127F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613B1F-7BFA-AC83-3D67-F590D5A7A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2DEB3B-1A91-7A6A-D3C9-764494001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25A00C-2288-CB3C-5759-0D47CD9DD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030040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4920C5-BFFA-3D1F-3B27-E01F31DF5B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729A87-9579-E813-0F00-01CC29B869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3069F0-57E0-291C-C893-441A35F84F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14B962-3A4F-E79B-10F4-082FF7BC33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F34186A-C1C3-C811-73BB-121956C867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10EC3F-71E5-EB75-7FB6-78BD87C044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AE3F0F-D43D-A83A-AD34-294AAA1202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4608B7-A967-1DC4-B43B-C7751E9BB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814869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AFB27-E692-4F87-0CE0-58DAED7CD1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F3CE60-0F6B-D730-1DCD-F71C15E5D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5702FE-3291-967B-33DD-7BCB3F646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E3C8B7-A1E4-8BAB-8F92-EDF719847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879418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42331D5-E06B-D690-1AC2-C7D4164425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8FD961-587A-104F-3FC5-6952DFAC6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B013E7-0B7F-D9CD-F897-14A07216A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579860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A68099-1554-ECEE-F9A8-91018EEB7C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9998D6-3EFE-ED93-A78C-0784A57E85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43CD8E-1585-FA5D-B0CE-E3413FFECF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45DD25-6B59-FB8F-DE87-189E491D02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83D157-1012-8344-0499-4DEA2A8E0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9BCDAD-ACCD-FC84-DC1C-07EC7F871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895691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81F48A-EA5D-7DF4-918B-2E581FA2C6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2B2B3BF-C80A-0F89-46AA-03212E6DF5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E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5E1159-3AEB-BA95-C102-0ECC211319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DB3D6F-B754-CE7E-9A03-7B0056DEDC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F09CD4-B405-541B-F716-073331F69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812952-352B-FEF1-1F5C-6000E7017D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3455246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9CCA994-9F1E-06C3-FC4C-7718EE8A1C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E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3236E9-1FE1-2879-8082-8D2CB11744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45C2F1-E1EC-D12F-186F-88447E963E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D4A56F3-F31F-FF4E-A3E7-4BA2807A17E7}" type="datetimeFigureOut">
              <a:rPr lang="en-ES" smtClean="0"/>
              <a:t>9/4/26</a:t>
            </a:fld>
            <a:endParaRPr lang="en-E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19D3BA-4E7F-EDB5-8584-13CF054E3AC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0D1805-1EF7-D0CE-B2AA-9DEB8AE17C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AF8DB2C-9A9C-E84D-B1D4-BFEA2C94A206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431946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of a positive rate&#10;&#10;Description automatically generated">
            <a:extLst>
              <a:ext uri="{FF2B5EF4-FFF2-40B4-BE49-F238E27FC236}">
                <a16:creationId xmlns:a16="http://schemas.microsoft.com/office/drawing/2014/main" id="{B39D7A44-ADB2-8A2D-4CFF-2EF2557914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8609" y="1789630"/>
            <a:ext cx="3626958" cy="3633401"/>
          </a:xfrm>
          <a:prstGeom prst="rect">
            <a:avLst/>
          </a:prstGeom>
        </p:spPr>
      </p:pic>
      <p:pic>
        <p:nvPicPr>
          <p:cNvPr id="3" name="Picture 2" descr="A graph of a positive rate&#10;&#10;Description automatically generated">
            <a:extLst>
              <a:ext uri="{FF2B5EF4-FFF2-40B4-BE49-F238E27FC236}">
                <a16:creationId xmlns:a16="http://schemas.microsoft.com/office/drawing/2014/main" id="{B043B81E-5DB6-38E9-6175-B8247D42C5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82521" y="1789630"/>
            <a:ext cx="3626958" cy="3633401"/>
          </a:xfrm>
          <a:prstGeom prst="rect">
            <a:avLst/>
          </a:prstGeom>
        </p:spPr>
      </p:pic>
      <p:pic>
        <p:nvPicPr>
          <p:cNvPr id="4" name="Picture 3" descr="A graph of a positive rate&#10;&#10;Description automatically generated">
            <a:extLst>
              <a:ext uri="{FF2B5EF4-FFF2-40B4-BE49-F238E27FC236}">
                <a16:creationId xmlns:a16="http://schemas.microsoft.com/office/drawing/2014/main" id="{1F40D369-C9BE-A7EC-7115-5D48AF8F707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68720" y="1789630"/>
            <a:ext cx="3626960" cy="3633403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9AB6BF-7DAA-8E21-252C-B54521601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3827D0-D7DA-D74A-8088-55E2732B8002}" type="slidenum">
              <a:rPr lang="en-US" smtClean="0"/>
              <a:t>1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784DC0E-3251-21F6-3C47-FFF73C8B9723}"/>
              </a:ext>
            </a:extLst>
          </p:cNvPr>
          <p:cNvSpPr txBox="1"/>
          <p:nvPr/>
        </p:nvSpPr>
        <p:spPr>
          <a:xfrm>
            <a:off x="648971" y="501063"/>
            <a:ext cx="30697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eville</a:t>
            </a: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n=28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51404CE-B711-C1E3-D71A-21FB5F5DDC55}"/>
              </a:ext>
            </a:extLst>
          </p:cNvPr>
          <p:cNvSpPr txBox="1"/>
          <p:nvPr/>
        </p:nvSpPr>
        <p:spPr>
          <a:xfrm>
            <a:off x="4671228" y="501063"/>
            <a:ext cx="30697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ES"/>
            </a:defPPr>
            <a:lvl1pPr algn="ctr"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arcelona</a:t>
            </a:r>
          </a:p>
          <a:p>
            <a:r>
              <a:rPr lang="en-US" dirty="0"/>
              <a:t> n=13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B4911AB-A3D7-2A52-8EB2-0FA2F4AA3652}"/>
              </a:ext>
            </a:extLst>
          </p:cNvPr>
          <p:cNvSpPr txBox="1"/>
          <p:nvPr/>
        </p:nvSpPr>
        <p:spPr>
          <a:xfrm>
            <a:off x="8610600" y="501063"/>
            <a:ext cx="30697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ES"/>
            </a:defPPr>
            <a:lvl1pPr algn="ctr"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ombined</a:t>
            </a:r>
          </a:p>
          <a:p>
            <a:r>
              <a:rPr lang="en-US" dirty="0"/>
              <a:t>n=417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E14E38-E84F-14C9-1DB2-186F8137B16A}"/>
              </a:ext>
            </a:extLst>
          </p:cNvPr>
          <p:cNvSpPr txBox="1"/>
          <p:nvPr/>
        </p:nvSpPr>
        <p:spPr>
          <a:xfrm>
            <a:off x="59267" y="6211669"/>
            <a:ext cx="1208188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Supplementary Figure S1.</a:t>
            </a:r>
            <a:r>
              <a:rPr lang="en-GB" dirty="0"/>
              <a:t> </a:t>
            </a:r>
            <a:r>
              <a:rPr lang="en-GB" dirty="0">
                <a:solidFill>
                  <a:srgbClr val="0E0E0E"/>
                </a:solidFill>
                <a:effectLst/>
                <a:latin typeface="Helvetica Neue" panose="02000503000000020004" pitchFamily="2" charset="0"/>
              </a:rPr>
              <a:t>Time-dependent ROC curves at 2 years for the 4-variable Kidney Failure Risk Equation (KFRE), stratified by </a:t>
            </a:r>
            <a:r>
              <a:rPr lang="en-GB" dirty="0" err="1">
                <a:solidFill>
                  <a:srgbClr val="0E0E0E"/>
                </a:solidFill>
                <a:effectLst/>
                <a:latin typeface="Helvetica Neue" panose="02000503000000020004" pitchFamily="2" charset="0"/>
              </a:rPr>
              <a:t>center</a:t>
            </a:r>
            <a:r>
              <a:rPr lang="en-GB" dirty="0">
                <a:solidFill>
                  <a:srgbClr val="0E0E0E"/>
                </a:solidFill>
                <a:effectLst/>
                <a:latin typeface="Helvetica Neue" panose="02000503000000020004" pitchFamily="2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3795123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39</Words>
  <Application>Microsoft Macintosh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Helvetica Neu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éstor Toapanta Gaibor</dc:creator>
  <cp:lastModifiedBy>Néstor Toapanta Gaibor</cp:lastModifiedBy>
  <cp:revision>2</cp:revision>
  <dcterms:created xsi:type="dcterms:W3CDTF">2026-04-09T21:00:01Z</dcterms:created>
  <dcterms:modified xsi:type="dcterms:W3CDTF">2026-04-09T21:09:05Z</dcterms:modified>
</cp:coreProperties>
</file>